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1" d="100"/>
          <a:sy n="71" d="100"/>
        </p:scale>
        <p:origin x="61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DB67-D01D-4FDD-959C-549159D9DD5A}" type="datetimeFigureOut">
              <a:rPr lang="en-GB" smtClean="0"/>
              <a:t>18/01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4736-A97C-4E59-9CDA-97E6239C1A4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7330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DB67-D01D-4FDD-959C-549159D9DD5A}" type="datetimeFigureOut">
              <a:rPr lang="en-GB" smtClean="0"/>
              <a:t>18/01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4736-A97C-4E59-9CDA-97E6239C1A4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57028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DB67-D01D-4FDD-959C-549159D9DD5A}" type="datetimeFigureOut">
              <a:rPr lang="en-GB" smtClean="0"/>
              <a:t>18/01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4736-A97C-4E59-9CDA-97E6239C1A4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21695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DB67-D01D-4FDD-959C-549159D9DD5A}" type="datetimeFigureOut">
              <a:rPr lang="en-GB" smtClean="0"/>
              <a:t>18/01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4736-A97C-4E59-9CDA-97E6239C1A4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75975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DB67-D01D-4FDD-959C-549159D9DD5A}" type="datetimeFigureOut">
              <a:rPr lang="en-GB" smtClean="0"/>
              <a:t>18/01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4736-A97C-4E59-9CDA-97E6239C1A4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8103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DB67-D01D-4FDD-959C-549159D9DD5A}" type="datetimeFigureOut">
              <a:rPr lang="en-GB" smtClean="0"/>
              <a:t>18/01/2022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4736-A97C-4E59-9CDA-97E6239C1A4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58054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DB67-D01D-4FDD-959C-549159D9DD5A}" type="datetimeFigureOut">
              <a:rPr lang="en-GB" smtClean="0"/>
              <a:t>18/01/2022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4736-A97C-4E59-9CDA-97E6239C1A4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13453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DB67-D01D-4FDD-959C-549159D9DD5A}" type="datetimeFigureOut">
              <a:rPr lang="en-GB" smtClean="0"/>
              <a:t>18/01/2022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4736-A97C-4E59-9CDA-97E6239C1A4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6743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DB67-D01D-4FDD-959C-549159D9DD5A}" type="datetimeFigureOut">
              <a:rPr lang="en-GB" smtClean="0"/>
              <a:t>18/01/2022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4736-A97C-4E59-9CDA-97E6239C1A4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7270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DB67-D01D-4FDD-959C-549159D9DD5A}" type="datetimeFigureOut">
              <a:rPr lang="en-GB" smtClean="0"/>
              <a:t>18/01/2022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4736-A97C-4E59-9CDA-97E6239C1A4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574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DB67-D01D-4FDD-959C-549159D9DD5A}" type="datetimeFigureOut">
              <a:rPr lang="en-GB" smtClean="0"/>
              <a:t>18/01/2022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4736-A97C-4E59-9CDA-97E6239C1A4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50495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C2DB67-D01D-4FDD-959C-549159D9DD5A}" type="datetimeFigureOut">
              <a:rPr lang="en-GB" smtClean="0"/>
              <a:t>18/01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A54736-A97C-4E59-9CDA-97E6239C1A4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24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3127" y="174562"/>
            <a:ext cx="11839699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2000" b="1">
                <a:latin typeface="Times New Roman" panose="02020603050405020304" pitchFamily="18" charset="0"/>
                <a:cs typeface="Times New Roman" panose="02020603050405020304" pitchFamily="18" charset="0"/>
              </a:rPr>
              <a:t>file </a:t>
            </a:r>
            <a:r>
              <a:rPr lang="fr-FR" sz="20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 </a:t>
            </a:r>
            <a:r>
              <a:rPr lang="fr-F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fr-FR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fr-F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n-US" sz="20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. gambiae </a:t>
            </a:r>
            <a:r>
              <a:rPr lang="en-US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.l.</a:t>
            </a:r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osquitoes 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dentified among the alive and dead </a:t>
            </a:r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 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osure to </a:t>
            </a:r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secticides. </a:t>
            </a:r>
            <a:endParaRPr 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ableau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097244"/>
              </p:ext>
            </p:extLst>
          </p:nvPr>
        </p:nvGraphicFramePr>
        <p:xfrm>
          <a:off x="2111186" y="1129556"/>
          <a:ext cx="7268732" cy="5097372"/>
        </p:xfrm>
        <a:graphic>
          <a:graphicData uri="http://schemas.openxmlformats.org/drawingml/2006/table">
            <a:tbl>
              <a:tblPr firstRow="1" firstCol="1" bandRow="1"/>
              <a:tblGrid>
                <a:gridCol w="1567206"/>
                <a:gridCol w="726302"/>
                <a:gridCol w="1567206"/>
                <a:gridCol w="568003"/>
                <a:gridCol w="568003"/>
                <a:gridCol w="568003"/>
                <a:gridCol w="568003"/>
                <a:gridCol w="568003"/>
                <a:gridCol w="568003"/>
              </a:tblGrid>
              <a:tr h="583919">
                <a:tc rowSpan="2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ocality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umber analysed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pecies (number)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err="1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ndiocarb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fr-FR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err="1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irimiphos</a:t>
                      </a: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fr-FR" sz="1200" dirty="0" err="1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thyl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fr-FR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err="1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poxur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296942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live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ad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live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ad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live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ad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56265">
                <a:tc rowSpan="2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err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rtoua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8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i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. gambiae (17)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96942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i="1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. coluzzii (171)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0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1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6942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err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bolowa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0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i="1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. coluzzii (150)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8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4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8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6942">
                <a:tc rowSpan="2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err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dea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5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i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. gambiae (67)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7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6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96942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i="1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. coluzzii (88)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2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5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6942">
                <a:tc rowSpan="2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err="1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onaberi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3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i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. gambiae (22)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96942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i="1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. coluzzii (41)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1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6942">
                <a:tc rowSpan="2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err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ounougou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8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i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. arabiensis (68)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6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96942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i="1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. coluzzii (110)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2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6942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err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ngoum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52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i="1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. gambiae (252)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7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5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8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6942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err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yabessang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5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i="1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. gambiae (145)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8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8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6942">
                <a:tc rowSpan="2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err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kolbisson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1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i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. gambiae (47)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9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96942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i="1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. coluzzii (14)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6942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imatou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1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i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. coluzzii (81)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2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1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26" marR="47226" marT="81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7139834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226</Words>
  <Application>Microsoft Office PowerPoint</Application>
  <PresentationFormat>Grand écran</PresentationFormat>
  <Paragraphs>12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erome Achille BINYANG</dc:creator>
  <cp:lastModifiedBy>Jerome Achille BINYANG</cp:lastModifiedBy>
  <cp:revision>2</cp:revision>
  <dcterms:created xsi:type="dcterms:W3CDTF">2022-01-18T17:31:23Z</dcterms:created>
  <dcterms:modified xsi:type="dcterms:W3CDTF">2022-01-18T17:54:17Z</dcterms:modified>
</cp:coreProperties>
</file>